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104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68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374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482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669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1595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013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789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041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127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632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013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hyperlink" Target="http://www.biolegend.com/index.php?page=pro_sub_cat&amp;action=search_clone&amp;criteria=RTK4530" TargetMode="External"/><Relationship Id="rId13" Type="http://schemas.openxmlformats.org/officeDocument/2006/relationships/hyperlink" Target="http://www.biolegend.com/pe-rat-igg2a-kappa-isotype-control-1843.html" TargetMode="External"/><Relationship Id="rId3" Type="http://schemas.openxmlformats.org/officeDocument/2006/relationships/hyperlink" Target="http://www.bdbiosciences.com/ptProduct.jsp?prodId=8281&amp;key=554689&amp;param=search&amp;mterms=true&amp;from=dTable" TargetMode="External"/><Relationship Id="rId7" Type="http://schemas.openxmlformats.org/officeDocument/2006/relationships/hyperlink" Target="http://www.bdbiosciences.com/ptProduct.jsp?prodId=103168&amp;key=550765&amp;param=search&amp;mterms=true&amp;from=dTable" TargetMode="External"/><Relationship Id="rId12" Type="http://schemas.openxmlformats.org/officeDocument/2006/relationships/hyperlink" Target="http://www.biolegend.com/index.php?page=pro_sub_cat&amp;action=search_clone&amp;criteria=RTK2758" TargetMode="External"/><Relationship Id="rId2" Type="http://schemas.openxmlformats.org/officeDocument/2006/relationships/hyperlink" Target="http://www.bdbiosciences.com/ptProduct.jsp?prodId=204168&amp;key=552126&amp;param=search&amp;mterms=true&amp;from=dTable" TargetMode="External"/><Relationship Id="rId1" Type="http://schemas.openxmlformats.org/officeDocument/2006/relationships/slideLayout" Target="../slideLayouts/slideLayout7.xml"/><Relationship Id="rId6" Type="http://schemas.openxmlformats.org/officeDocument/2006/relationships/hyperlink" Target="http://www.bdbiosciences.com/ptProduct.jsp?prodId=741465&amp;key=560602&amp;param=search&amp;mterms=true&amp;from=dTable" TargetMode="External"/><Relationship Id="rId11" Type="http://schemas.openxmlformats.org/officeDocument/2006/relationships/hyperlink" Target="http://www.biolegend.com/pe-anti-mouse-f4-80-antibody-4068.html" TargetMode="External"/><Relationship Id="rId5" Type="http://schemas.openxmlformats.org/officeDocument/2006/relationships/hyperlink" Target="http://www.bdbiosciences.com/ptProduct.jsp?prodId=1340012&amp;key=562602&amp;param=search&amp;mterms=true&amp;from=dTable" TargetMode="External"/><Relationship Id="rId10" Type="http://schemas.openxmlformats.org/officeDocument/2006/relationships/hyperlink" Target="http://www.biolegend.com/index.php?page=pro_sub_cat&amp;action=search_clone&amp;criteria=BM8" TargetMode="External"/><Relationship Id="rId4" Type="http://schemas.openxmlformats.org/officeDocument/2006/relationships/hyperlink" Target="http://www.bdbiosciences.com/ptProduct.jsp?prodId=1487121&amp;key=562681&amp;param=search&amp;mterms=true&amp;from=dTable" TargetMode="External"/><Relationship Id="rId9" Type="http://schemas.openxmlformats.org/officeDocument/2006/relationships/hyperlink" Target="http://www.biolegend.com/apc-rat-igg2b-kappa-isotype-control-1851.html" TargetMode="External"/><Relationship Id="rId14" Type="http://schemas.openxmlformats.org/officeDocument/2006/relationships/hyperlink" Target="http://www.biolegend.com/foxp3-fix-perm-buffer-set-2915.html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68271767"/>
              </p:ext>
            </p:extLst>
          </p:nvPr>
        </p:nvGraphicFramePr>
        <p:xfrm>
          <a:off x="228599" y="1967847"/>
          <a:ext cx="8762999" cy="3670953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515845"/>
                <a:gridCol w="1326703"/>
                <a:gridCol w="912109"/>
                <a:gridCol w="5008342"/>
              </a:tblGrid>
              <a:tr h="25520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Name of antibod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lone #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ompan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information websit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 anchor="ctr"/>
                </a:tc>
              </a:tr>
              <a:tr h="201975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Used for </a:t>
                      </a:r>
                      <a:r>
                        <a:rPr lang="en-US" sz="800" dirty="0" err="1">
                          <a:effectLst/>
                        </a:rPr>
                        <a:t>fluroscent</a:t>
                      </a:r>
                      <a:r>
                        <a:rPr lang="en-US" sz="800" dirty="0">
                          <a:effectLst/>
                        </a:rPr>
                        <a:t> staining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 anchor="b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 anchor="b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 anchor="b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 anchor="b"/>
                </a:tc>
              </a:tr>
              <a:tr h="280416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PE Rat Anti-Mouse </a:t>
                      </a:r>
                      <a:r>
                        <a:rPr lang="en-US" sz="800" dirty="0" err="1">
                          <a:effectLst/>
                        </a:rPr>
                        <a:t>Siglec</a:t>
                      </a:r>
                      <a:r>
                        <a:rPr lang="en-US" sz="800" dirty="0">
                          <a:effectLst/>
                        </a:rPr>
                        <a:t>-F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E50-244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BD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 baseline="0" dirty="0">
                          <a:solidFill>
                            <a:schemeClr val="tx1"/>
                          </a:solidFill>
                          <a:effectLst/>
                          <a:hlinkClick r:id="rId2"/>
                        </a:rPr>
                        <a:t>http://www.bdbiosciences.com/ptProduct.jsp?prodId=204168&amp;key=552126&amp;param=search&amp;mterms=true&amp;from=dTable</a:t>
                      </a:r>
                      <a:endParaRPr lang="en-US" sz="800" baseline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</a:tr>
              <a:tr h="280416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at (LOU) IgG2a, κ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R35-95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BD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 dirty="0">
                          <a:effectLst/>
                          <a:hlinkClick r:id="rId3"/>
                        </a:rPr>
                        <a:t>http://www.bdbiosciences.com/ptProduct.jsp?prodId=8281&amp;key=554689&amp;param=search&amp;mterms=true&amp;from=dTable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</a:tr>
              <a:tr h="31403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sed for FACS staining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40901" marR="40901" marT="0" marB="0"/>
                </a:tc>
              </a:tr>
              <a:tr h="31403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Brilliant Violet™ 421 Rat Anti-Mouse Siglec-F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E50-244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BD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 dirty="0">
                          <a:effectLst/>
                          <a:hlinkClick r:id="rId4"/>
                        </a:rPr>
                        <a:t>http://www.bdbiosciences.com/ptProduct.jsp?prodId=1487121&amp;key=562681&amp;param=search&amp;mterms=true&amp;from=dTable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</a:tr>
              <a:tr h="31403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Brilliant Violet™ 421 Rat IgG2a, κ Isotype Control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35-95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BD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 dirty="0">
                          <a:effectLst/>
                          <a:hlinkClick r:id="rId5"/>
                        </a:rPr>
                        <a:t>http://www.bdbiosciences.com/ptProduct.jsp?prodId=1340012&amp;key=562602&amp;param=search&amp;mterms=true&amp;from=dTable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</a:tr>
              <a:tr h="15743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40901" marR="40901" marT="0" marB="0"/>
                </a:tc>
              </a:tr>
              <a:tr h="280416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erCP-Cy™5.5 Rat Anti-Mouse Ly-6G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A8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BD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 dirty="0">
                          <a:effectLst/>
                          <a:hlinkClick r:id="rId6"/>
                        </a:rPr>
                        <a:t>http://www.bdbiosciences.com/ptProduct.jsp?prodId=741465&amp;key=560602&amp;param=search&amp;mterms=true&amp;from=dTable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</a:tr>
              <a:tr h="31403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erCP-Cy™5.5 Rat IgG2a, κ Isotype Control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35-95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BD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 dirty="0">
                          <a:effectLst/>
                          <a:hlinkClick r:id="rId7"/>
                        </a:rPr>
                        <a:t>http://www.bdbiosciences.com/ptProduct.jsp?prodId=103168&amp;key=550765&amp;param=search&amp;mterms=true&amp;from=dTable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</a:tr>
              <a:tr h="15743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APC Rat IgG2b, κ Isotype Ctrl Antibody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>
                          <a:effectLst/>
                          <a:hlinkClick r:id="rId8" tooltip="View All Formats"/>
                        </a:rPr>
                        <a:t>RTK4530 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Biolegend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 dirty="0">
                          <a:effectLst/>
                          <a:hlinkClick r:id="rId9"/>
                        </a:rPr>
                        <a:t>http://www.biolegend.com/apc-rat-igg2b-kappa-isotype-control-1851.html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</a:tr>
              <a:tr h="20705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PE anti-mouse F4/80 Antibody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 dirty="0">
                          <a:effectLst/>
                          <a:hlinkClick r:id="rId10" tooltip="View All Formats"/>
                        </a:rPr>
                        <a:t>BM8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 err="1">
                          <a:effectLst/>
                        </a:rPr>
                        <a:t>Biolegend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 dirty="0">
                          <a:effectLst/>
                          <a:hlinkClick r:id="rId11"/>
                        </a:rPr>
                        <a:t>http://www.biolegend.com/pe-anti-mouse-f4-80-antibody-4068.html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</a:tr>
              <a:tr h="31403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PE Rat IgG2a, κ Isotype Ctrl Antibody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>
                          <a:effectLst/>
                          <a:hlinkClick r:id="rId12" tooltip="View All Formats"/>
                        </a:rPr>
                        <a:t>RTK2758 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>
                          <a:effectLst/>
                        </a:rPr>
                        <a:t>Biolegend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 dirty="0">
                          <a:effectLst/>
                          <a:hlinkClick r:id="rId13"/>
                        </a:rPr>
                        <a:t>http://www.biolegend.com/pe-rat-igg2a-kappa-isotype-control-1843.html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</a:tr>
              <a:tr h="15743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FOXP3 Fix/Perm Buffer Set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effectLst/>
                        </a:rPr>
                        <a:t>Biolegend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sng" dirty="0">
                          <a:effectLst/>
                          <a:hlinkClick r:id="rId14"/>
                        </a:rPr>
                        <a:t>http://www.biolegend.com/foxp3-fix-perm-buffer-set-2915.html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901" marR="40901" marT="0" marB="0"/>
                </a:tc>
              </a:tr>
            </a:tbl>
          </a:graphicData>
        </a:graphic>
      </p:graphicFrame>
      <p:sp>
        <p:nvSpPr>
          <p:cNvPr id="10379" name="TextBox 6"/>
          <p:cNvSpPr txBox="1">
            <a:spLocks noChangeArrowheads="1"/>
          </p:cNvSpPr>
          <p:nvPr/>
        </p:nvSpPr>
        <p:spPr bwMode="auto">
          <a:xfrm>
            <a:off x="2286000" y="1066800"/>
            <a:ext cx="3749675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2000" dirty="0" smtClean="0"/>
              <a:t>S2 Table</a:t>
            </a:r>
            <a:r>
              <a:rPr lang="en-US" sz="2000" dirty="0"/>
              <a:t>.  Antibody information</a:t>
            </a:r>
          </a:p>
        </p:txBody>
      </p:sp>
    </p:spTree>
    <p:extLst>
      <p:ext uri="{BB962C8B-B14F-4D97-AF65-F5344CB8AC3E}">
        <p14:creationId xmlns:p14="http://schemas.microsoft.com/office/powerpoint/2010/main" val="40320655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6</TotalTime>
  <Words>133</Words>
  <Application>Microsoft Office PowerPoint</Application>
  <PresentationFormat>On-screen Show (4:3)</PresentationFormat>
  <Paragraphs>5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SH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NO1</dc:creator>
  <cp:lastModifiedBy>Sharifi, Behrooz, Ph.D.</cp:lastModifiedBy>
  <cp:revision>36</cp:revision>
  <dcterms:created xsi:type="dcterms:W3CDTF">2014-06-16T22:30:49Z</dcterms:created>
  <dcterms:modified xsi:type="dcterms:W3CDTF">2015-04-13T19:31:50Z</dcterms:modified>
</cp:coreProperties>
</file>